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8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FAFA"/>
    <a:srgbClr val="007E77"/>
    <a:srgbClr val="FF8AD8"/>
    <a:srgbClr val="F2F2F2"/>
    <a:srgbClr val="5C66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87" autoAdjust="0"/>
    <p:restoredTop sz="94277"/>
  </p:normalViewPr>
  <p:slideViewPr>
    <p:cSldViewPr snapToGrid="0">
      <p:cViewPr varScale="1">
        <p:scale>
          <a:sx n="75" d="100"/>
          <a:sy n="7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E9E69-94B8-6846-8831-8FFB33FB9D64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FD0DA-937E-B24B-9D15-1C64ED810B6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7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3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833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95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4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8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6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0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8774464"/>
              </p:ext>
            </p:extLst>
          </p:nvPr>
        </p:nvGraphicFramePr>
        <p:xfrm>
          <a:off x="608772" y="1940833"/>
          <a:ext cx="5299959" cy="3202476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875066">
                  <a:extLst>
                    <a:ext uri="{9D8B030D-6E8A-4147-A177-3AD203B41FA5}">
                      <a16:colId xmlns:a16="http://schemas.microsoft.com/office/drawing/2014/main" val="394520897"/>
                    </a:ext>
                  </a:extLst>
                </a:gridCol>
                <a:gridCol w="1206906">
                  <a:extLst>
                    <a:ext uri="{9D8B030D-6E8A-4147-A177-3AD203B41FA5}">
                      <a16:colId xmlns:a16="http://schemas.microsoft.com/office/drawing/2014/main" val="4033384840"/>
                    </a:ext>
                  </a:extLst>
                </a:gridCol>
                <a:gridCol w="2198080">
                  <a:extLst>
                    <a:ext uri="{9D8B030D-6E8A-4147-A177-3AD203B41FA5}">
                      <a16:colId xmlns:a16="http://schemas.microsoft.com/office/drawing/2014/main" val="1422692253"/>
                    </a:ext>
                  </a:extLst>
                </a:gridCol>
                <a:gridCol w="1019907">
                  <a:extLst>
                    <a:ext uri="{9D8B030D-6E8A-4147-A177-3AD203B41FA5}">
                      <a16:colId xmlns:a16="http://schemas.microsoft.com/office/drawing/2014/main" val="1003998249"/>
                    </a:ext>
                  </a:extLst>
                </a:gridCol>
              </a:tblGrid>
              <a:tr h="322476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 segme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 (5’-&gt; 3’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</a:t>
                      </a:r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ize</a:t>
                      </a:r>
                    </a:p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1375072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1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1-PCR-U1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GAAAGCAGGTCAAATATATTC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4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294483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1-PCR-U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TCGTTTTTAAAC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624384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2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2-PCR-U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GAAAGCAGGCAAACCATTT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41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8501820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2-PCR-U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CATTTTTTCAT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3183991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3 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3-PCR-U1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GAAAGCAGGTACTGATCC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3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1257721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3-PCR-U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TACTTTTTTGG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1084716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4-PCR-U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AAGCAGGGGATATTTCTG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68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2451333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4-PCR-U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GTGTTTTTAA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0587133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5-PCR-U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AAGCAGGGTAGATAATC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65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5248659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5-PCR-U13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GTATTTTTCTT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1364709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6-PCR-U1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AAGCAGGAGTTTAAAATGA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2184295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6-PCR-U1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AGTTTTTTCG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8647890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7-PCR-U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AAGCAGGTAGATATTTAAAG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8899012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7-PCR-U1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TAGTTTTTTAC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0481928"/>
                  </a:ext>
                </a:extLst>
              </a:tr>
              <a:tr h="180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gment 8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8-PCR-U12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AAGCAGGGTGACAAAAAC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0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AFA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3971681"/>
                  </a:ext>
                </a:extLst>
              </a:tr>
              <a:tr h="180000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8-PCR-U13</a:t>
                      </a:r>
                      <a:endParaRPr lang="fr-F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08" marR="8908" marT="8908" marB="0" anchor="ctr">
                    <a:solidFill>
                      <a:srgbClr val="FA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AGAAACAAGGGTGTTTTTTATC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0347" marR="8908" marT="8908" marB="0" anchor="ctr">
                    <a:solidFill>
                      <a:srgbClr val="FAFA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26961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29979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176</TotalTime>
  <Words>72</Words>
  <Application>Microsoft Macintosh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 POLLET</dc:creator>
  <cp:lastModifiedBy>Lena Kleij</cp:lastModifiedBy>
  <cp:revision>238</cp:revision>
  <cp:lastPrinted>2023-10-09T13:57:45Z</cp:lastPrinted>
  <dcterms:created xsi:type="dcterms:W3CDTF">2023-02-16T15:54:12Z</dcterms:created>
  <dcterms:modified xsi:type="dcterms:W3CDTF">2023-10-24T12:37:02Z</dcterms:modified>
</cp:coreProperties>
</file>